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4"/>
  </p:sldMasterIdLst>
  <p:sldIdLst>
    <p:sldId id="256" r:id="rId5"/>
  </p:sldIdLst>
  <p:sldSz cx="3263900" cy="2381250"/>
  <p:notesSz cx="3263900" cy="238125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F9F9F"/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28" d="100"/>
          <a:sy n="328" d="100"/>
        </p:scale>
        <p:origin x="1716" y="2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245268" y="738187"/>
            <a:ext cx="2779712" cy="50006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490537" y="1333500"/>
            <a:ext cx="2289175" cy="59531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7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7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163512" y="547687"/>
            <a:ext cx="1422558" cy="15716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1684178" y="547687"/>
            <a:ext cx="1422558" cy="15716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7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7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7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402611" y="215098"/>
            <a:ext cx="57150" cy="1534795"/>
          </a:xfrm>
          <a:custGeom>
            <a:avLst/>
            <a:gdLst/>
            <a:ahLst/>
            <a:cxnLst/>
            <a:rect l="l" t="t" r="r" b="b"/>
            <a:pathLst>
              <a:path w="57150" h="1534795">
                <a:moveTo>
                  <a:pt x="56669" y="0"/>
                </a:moveTo>
                <a:lnTo>
                  <a:pt x="0" y="0"/>
                </a:lnTo>
                <a:lnTo>
                  <a:pt x="0" y="1534376"/>
                </a:lnTo>
                <a:lnTo>
                  <a:pt x="56669" y="1534376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g object 17"/>
          <p:cNvSpPr/>
          <p:nvPr/>
        </p:nvSpPr>
        <p:spPr>
          <a:xfrm>
            <a:off x="459281" y="218876"/>
            <a:ext cx="57150" cy="1530985"/>
          </a:xfrm>
          <a:custGeom>
            <a:avLst/>
            <a:gdLst/>
            <a:ahLst/>
            <a:cxnLst/>
            <a:rect l="l" t="t" r="r" b="b"/>
            <a:pathLst>
              <a:path w="57150" h="1530985">
                <a:moveTo>
                  <a:pt x="56772" y="0"/>
                </a:moveTo>
                <a:lnTo>
                  <a:pt x="0" y="0"/>
                </a:lnTo>
                <a:lnTo>
                  <a:pt x="0" y="1530598"/>
                </a:lnTo>
                <a:lnTo>
                  <a:pt x="56772" y="1530598"/>
                </a:lnTo>
                <a:lnTo>
                  <a:pt x="56772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g object 18"/>
          <p:cNvSpPr/>
          <p:nvPr/>
        </p:nvSpPr>
        <p:spPr>
          <a:xfrm>
            <a:off x="554037" y="1691886"/>
            <a:ext cx="57150" cy="57785"/>
          </a:xfrm>
          <a:custGeom>
            <a:avLst/>
            <a:gdLst/>
            <a:ahLst/>
            <a:cxnLst/>
            <a:rect l="l" t="t" r="r" b="b"/>
            <a:pathLst>
              <a:path w="57150" h="57785">
                <a:moveTo>
                  <a:pt x="56669" y="0"/>
                </a:moveTo>
                <a:lnTo>
                  <a:pt x="0" y="0"/>
                </a:lnTo>
                <a:lnTo>
                  <a:pt x="0" y="57588"/>
                </a:lnTo>
                <a:lnTo>
                  <a:pt x="56669" y="57588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bg object 19"/>
          <p:cNvSpPr/>
          <p:nvPr/>
        </p:nvSpPr>
        <p:spPr>
          <a:xfrm>
            <a:off x="610707" y="1659620"/>
            <a:ext cx="57150" cy="90170"/>
          </a:xfrm>
          <a:custGeom>
            <a:avLst/>
            <a:gdLst/>
            <a:ahLst/>
            <a:cxnLst/>
            <a:rect l="l" t="t" r="r" b="b"/>
            <a:pathLst>
              <a:path w="57150" h="90169">
                <a:moveTo>
                  <a:pt x="56669" y="0"/>
                </a:moveTo>
                <a:lnTo>
                  <a:pt x="0" y="0"/>
                </a:lnTo>
                <a:lnTo>
                  <a:pt x="0" y="89855"/>
                </a:lnTo>
                <a:lnTo>
                  <a:pt x="56669" y="89855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bg object 20"/>
          <p:cNvSpPr/>
          <p:nvPr/>
        </p:nvSpPr>
        <p:spPr>
          <a:xfrm>
            <a:off x="705362" y="1588757"/>
            <a:ext cx="57150" cy="161290"/>
          </a:xfrm>
          <a:custGeom>
            <a:avLst/>
            <a:gdLst/>
            <a:ahLst/>
            <a:cxnLst/>
            <a:rect l="l" t="t" r="r" b="b"/>
            <a:pathLst>
              <a:path w="57150" h="161289">
                <a:moveTo>
                  <a:pt x="56772" y="0"/>
                </a:moveTo>
                <a:lnTo>
                  <a:pt x="0" y="0"/>
                </a:lnTo>
                <a:lnTo>
                  <a:pt x="0" y="160717"/>
                </a:lnTo>
                <a:lnTo>
                  <a:pt x="56772" y="160717"/>
                </a:lnTo>
                <a:lnTo>
                  <a:pt x="56772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bg object 21"/>
          <p:cNvSpPr/>
          <p:nvPr/>
        </p:nvSpPr>
        <p:spPr>
          <a:xfrm>
            <a:off x="762134" y="1622555"/>
            <a:ext cx="57150" cy="127000"/>
          </a:xfrm>
          <a:custGeom>
            <a:avLst/>
            <a:gdLst/>
            <a:ahLst/>
            <a:cxnLst/>
            <a:rect l="l" t="t" r="r" b="b"/>
            <a:pathLst>
              <a:path w="57150" h="127000">
                <a:moveTo>
                  <a:pt x="56669" y="0"/>
                </a:moveTo>
                <a:lnTo>
                  <a:pt x="0" y="0"/>
                </a:lnTo>
                <a:lnTo>
                  <a:pt x="0" y="126920"/>
                </a:lnTo>
                <a:lnTo>
                  <a:pt x="56669" y="126920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bg object 22"/>
          <p:cNvSpPr/>
          <p:nvPr/>
        </p:nvSpPr>
        <p:spPr>
          <a:xfrm>
            <a:off x="856788" y="1740694"/>
            <a:ext cx="57150" cy="8890"/>
          </a:xfrm>
          <a:custGeom>
            <a:avLst/>
            <a:gdLst/>
            <a:ahLst/>
            <a:cxnLst/>
            <a:rect l="l" t="t" r="r" b="b"/>
            <a:pathLst>
              <a:path w="57150" h="8889">
                <a:moveTo>
                  <a:pt x="56669" y="0"/>
                </a:moveTo>
                <a:lnTo>
                  <a:pt x="0" y="0"/>
                </a:lnTo>
                <a:lnTo>
                  <a:pt x="0" y="8781"/>
                </a:lnTo>
                <a:lnTo>
                  <a:pt x="56669" y="8781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bg object 23"/>
          <p:cNvSpPr/>
          <p:nvPr/>
        </p:nvSpPr>
        <p:spPr>
          <a:xfrm>
            <a:off x="913458" y="1740490"/>
            <a:ext cx="57150" cy="9525"/>
          </a:xfrm>
          <a:custGeom>
            <a:avLst/>
            <a:gdLst/>
            <a:ahLst/>
            <a:cxnLst/>
            <a:rect l="l" t="t" r="r" b="b"/>
            <a:pathLst>
              <a:path w="57150" h="9525">
                <a:moveTo>
                  <a:pt x="56772" y="0"/>
                </a:moveTo>
                <a:lnTo>
                  <a:pt x="0" y="0"/>
                </a:lnTo>
                <a:lnTo>
                  <a:pt x="0" y="8985"/>
                </a:lnTo>
                <a:lnTo>
                  <a:pt x="56772" y="8985"/>
                </a:lnTo>
                <a:lnTo>
                  <a:pt x="56772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bg object 24"/>
          <p:cNvSpPr/>
          <p:nvPr/>
        </p:nvSpPr>
        <p:spPr>
          <a:xfrm>
            <a:off x="1008214" y="1729156"/>
            <a:ext cx="57150" cy="20320"/>
          </a:xfrm>
          <a:custGeom>
            <a:avLst/>
            <a:gdLst/>
            <a:ahLst/>
            <a:cxnLst/>
            <a:rect l="l" t="t" r="r" b="b"/>
            <a:pathLst>
              <a:path w="57150" h="20319">
                <a:moveTo>
                  <a:pt x="56669" y="0"/>
                </a:moveTo>
                <a:lnTo>
                  <a:pt x="0" y="0"/>
                </a:lnTo>
                <a:lnTo>
                  <a:pt x="0" y="20319"/>
                </a:lnTo>
                <a:lnTo>
                  <a:pt x="56669" y="20319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bg object 25"/>
          <p:cNvSpPr/>
          <p:nvPr/>
        </p:nvSpPr>
        <p:spPr>
          <a:xfrm>
            <a:off x="1064884" y="1735589"/>
            <a:ext cx="57150" cy="13970"/>
          </a:xfrm>
          <a:custGeom>
            <a:avLst/>
            <a:gdLst/>
            <a:ahLst/>
            <a:cxnLst/>
            <a:rect l="l" t="t" r="r" b="b"/>
            <a:pathLst>
              <a:path w="57150" h="13969">
                <a:moveTo>
                  <a:pt x="56669" y="0"/>
                </a:moveTo>
                <a:lnTo>
                  <a:pt x="0" y="0"/>
                </a:lnTo>
                <a:lnTo>
                  <a:pt x="0" y="13886"/>
                </a:lnTo>
                <a:lnTo>
                  <a:pt x="56669" y="13886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bg object 26"/>
          <p:cNvSpPr/>
          <p:nvPr/>
        </p:nvSpPr>
        <p:spPr>
          <a:xfrm>
            <a:off x="1159538" y="1747025"/>
            <a:ext cx="57150" cy="2540"/>
          </a:xfrm>
          <a:custGeom>
            <a:avLst/>
            <a:gdLst/>
            <a:ahLst/>
            <a:cxnLst/>
            <a:rect l="l" t="t" r="r" b="b"/>
            <a:pathLst>
              <a:path w="57150" h="2539">
                <a:moveTo>
                  <a:pt x="56772" y="0"/>
                </a:moveTo>
                <a:lnTo>
                  <a:pt x="0" y="0"/>
                </a:lnTo>
                <a:lnTo>
                  <a:pt x="0" y="2450"/>
                </a:lnTo>
                <a:lnTo>
                  <a:pt x="56772" y="2450"/>
                </a:lnTo>
                <a:lnTo>
                  <a:pt x="56772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bg object 27"/>
          <p:cNvSpPr/>
          <p:nvPr/>
        </p:nvSpPr>
        <p:spPr>
          <a:xfrm>
            <a:off x="1216310" y="1747739"/>
            <a:ext cx="57150" cy="1905"/>
          </a:xfrm>
          <a:custGeom>
            <a:avLst/>
            <a:gdLst/>
            <a:ahLst/>
            <a:cxnLst/>
            <a:rect l="l" t="t" r="r" b="b"/>
            <a:pathLst>
              <a:path w="57150" h="1905">
                <a:moveTo>
                  <a:pt x="56669" y="0"/>
                </a:moveTo>
                <a:lnTo>
                  <a:pt x="0" y="0"/>
                </a:lnTo>
                <a:lnTo>
                  <a:pt x="0" y="1735"/>
                </a:lnTo>
                <a:lnTo>
                  <a:pt x="56669" y="1735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bg object 28"/>
          <p:cNvSpPr/>
          <p:nvPr/>
        </p:nvSpPr>
        <p:spPr>
          <a:xfrm>
            <a:off x="1310964" y="1695358"/>
            <a:ext cx="57150" cy="54610"/>
          </a:xfrm>
          <a:custGeom>
            <a:avLst/>
            <a:gdLst/>
            <a:ahLst/>
            <a:cxnLst/>
            <a:rect l="l" t="t" r="r" b="b"/>
            <a:pathLst>
              <a:path w="57150" h="54610">
                <a:moveTo>
                  <a:pt x="56669" y="0"/>
                </a:moveTo>
                <a:lnTo>
                  <a:pt x="0" y="0"/>
                </a:lnTo>
                <a:lnTo>
                  <a:pt x="0" y="54117"/>
                </a:lnTo>
                <a:lnTo>
                  <a:pt x="56669" y="54117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bg object 29"/>
          <p:cNvSpPr/>
          <p:nvPr/>
        </p:nvSpPr>
        <p:spPr>
          <a:xfrm>
            <a:off x="1367634" y="1697809"/>
            <a:ext cx="57150" cy="52069"/>
          </a:xfrm>
          <a:custGeom>
            <a:avLst/>
            <a:gdLst/>
            <a:ahLst/>
            <a:cxnLst/>
            <a:rect l="l" t="t" r="r" b="b"/>
            <a:pathLst>
              <a:path w="57150" h="52069">
                <a:moveTo>
                  <a:pt x="56772" y="0"/>
                </a:moveTo>
                <a:lnTo>
                  <a:pt x="0" y="0"/>
                </a:lnTo>
                <a:lnTo>
                  <a:pt x="0" y="51666"/>
                </a:lnTo>
                <a:lnTo>
                  <a:pt x="56772" y="51666"/>
                </a:lnTo>
                <a:lnTo>
                  <a:pt x="56772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bg object 30"/>
          <p:cNvSpPr/>
          <p:nvPr/>
        </p:nvSpPr>
        <p:spPr>
          <a:xfrm>
            <a:off x="1462390" y="1749271"/>
            <a:ext cx="57150" cy="635"/>
          </a:xfrm>
          <a:custGeom>
            <a:avLst/>
            <a:gdLst/>
            <a:ahLst/>
            <a:cxnLst/>
            <a:rect l="l" t="t" r="r" b="b"/>
            <a:pathLst>
              <a:path w="57150" h="635">
                <a:moveTo>
                  <a:pt x="56669" y="0"/>
                </a:moveTo>
                <a:lnTo>
                  <a:pt x="0" y="0"/>
                </a:lnTo>
                <a:lnTo>
                  <a:pt x="0" y="204"/>
                </a:lnTo>
                <a:lnTo>
                  <a:pt x="56669" y="204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bg object 31"/>
          <p:cNvSpPr/>
          <p:nvPr/>
        </p:nvSpPr>
        <p:spPr>
          <a:xfrm>
            <a:off x="1613714" y="1693826"/>
            <a:ext cx="57150" cy="55880"/>
          </a:xfrm>
          <a:custGeom>
            <a:avLst/>
            <a:gdLst/>
            <a:ahLst/>
            <a:cxnLst/>
            <a:rect l="l" t="t" r="r" b="b"/>
            <a:pathLst>
              <a:path w="57150" h="55880">
                <a:moveTo>
                  <a:pt x="56772" y="0"/>
                </a:moveTo>
                <a:lnTo>
                  <a:pt x="0" y="0"/>
                </a:lnTo>
                <a:lnTo>
                  <a:pt x="0" y="55648"/>
                </a:lnTo>
                <a:lnTo>
                  <a:pt x="56772" y="55648"/>
                </a:lnTo>
                <a:lnTo>
                  <a:pt x="56772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bg object 32"/>
          <p:cNvSpPr/>
          <p:nvPr/>
        </p:nvSpPr>
        <p:spPr>
          <a:xfrm>
            <a:off x="1670486" y="1695971"/>
            <a:ext cx="57150" cy="53975"/>
          </a:xfrm>
          <a:custGeom>
            <a:avLst/>
            <a:gdLst/>
            <a:ahLst/>
            <a:cxnLst/>
            <a:rect l="l" t="t" r="r" b="b"/>
            <a:pathLst>
              <a:path w="57150" h="53975">
                <a:moveTo>
                  <a:pt x="56669" y="0"/>
                </a:moveTo>
                <a:lnTo>
                  <a:pt x="0" y="0"/>
                </a:lnTo>
                <a:lnTo>
                  <a:pt x="0" y="53504"/>
                </a:lnTo>
                <a:lnTo>
                  <a:pt x="56669" y="53504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bg object 33"/>
          <p:cNvSpPr/>
          <p:nvPr/>
        </p:nvSpPr>
        <p:spPr>
          <a:xfrm>
            <a:off x="1765140" y="1747944"/>
            <a:ext cx="57150" cy="1905"/>
          </a:xfrm>
          <a:custGeom>
            <a:avLst/>
            <a:gdLst/>
            <a:ahLst/>
            <a:cxnLst/>
            <a:rect l="l" t="t" r="r" b="b"/>
            <a:pathLst>
              <a:path w="57150" h="1905">
                <a:moveTo>
                  <a:pt x="56669" y="0"/>
                </a:moveTo>
                <a:lnTo>
                  <a:pt x="0" y="0"/>
                </a:lnTo>
                <a:lnTo>
                  <a:pt x="0" y="1531"/>
                </a:lnTo>
                <a:lnTo>
                  <a:pt x="56669" y="1531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bg object 34"/>
          <p:cNvSpPr/>
          <p:nvPr/>
        </p:nvSpPr>
        <p:spPr>
          <a:xfrm>
            <a:off x="1821810" y="1743247"/>
            <a:ext cx="57150" cy="6350"/>
          </a:xfrm>
          <a:custGeom>
            <a:avLst/>
            <a:gdLst/>
            <a:ahLst/>
            <a:cxnLst/>
            <a:rect l="l" t="t" r="r" b="b"/>
            <a:pathLst>
              <a:path w="57150" h="6350">
                <a:moveTo>
                  <a:pt x="56772" y="0"/>
                </a:moveTo>
                <a:lnTo>
                  <a:pt x="0" y="0"/>
                </a:lnTo>
                <a:lnTo>
                  <a:pt x="0" y="6228"/>
                </a:lnTo>
                <a:lnTo>
                  <a:pt x="56772" y="6228"/>
                </a:lnTo>
                <a:lnTo>
                  <a:pt x="56772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bg object 35"/>
          <p:cNvSpPr/>
          <p:nvPr/>
        </p:nvSpPr>
        <p:spPr>
          <a:xfrm>
            <a:off x="1916567" y="1743655"/>
            <a:ext cx="57150" cy="6350"/>
          </a:xfrm>
          <a:custGeom>
            <a:avLst/>
            <a:gdLst/>
            <a:ahLst/>
            <a:cxnLst/>
            <a:rect l="l" t="t" r="r" b="b"/>
            <a:pathLst>
              <a:path w="57150" h="6350">
                <a:moveTo>
                  <a:pt x="56669" y="0"/>
                </a:moveTo>
                <a:lnTo>
                  <a:pt x="0" y="0"/>
                </a:lnTo>
                <a:lnTo>
                  <a:pt x="0" y="5820"/>
                </a:lnTo>
                <a:lnTo>
                  <a:pt x="56669" y="5820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bg object 36"/>
          <p:cNvSpPr/>
          <p:nvPr/>
        </p:nvSpPr>
        <p:spPr>
          <a:xfrm>
            <a:off x="1973237" y="1739162"/>
            <a:ext cx="57150" cy="10795"/>
          </a:xfrm>
          <a:custGeom>
            <a:avLst/>
            <a:gdLst/>
            <a:ahLst/>
            <a:cxnLst/>
            <a:rect l="l" t="t" r="r" b="b"/>
            <a:pathLst>
              <a:path w="57150" h="10794">
                <a:moveTo>
                  <a:pt x="56669" y="0"/>
                </a:moveTo>
                <a:lnTo>
                  <a:pt x="0" y="0"/>
                </a:lnTo>
                <a:lnTo>
                  <a:pt x="0" y="10312"/>
                </a:lnTo>
                <a:lnTo>
                  <a:pt x="56669" y="10312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bg object 37"/>
          <p:cNvSpPr/>
          <p:nvPr/>
        </p:nvSpPr>
        <p:spPr>
          <a:xfrm>
            <a:off x="2067891" y="1745799"/>
            <a:ext cx="57150" cy="3810"/>
          </a:xfrm>
          <a:custGeom>
            <a:avLst/>
            <a:gdLst/>
            <a:ahLst/>
            <a:cxnLst/>
            <a:rect l="l" t="t" r="r" b="b"/>
            <a:pathLst>
              <a:path w="57150" h="3810">
                <a:moveTo>
                  <a:pt x="56772" y="0"/>
                </a:moveTo>
                <a:lnTo>
                  <a:pt x="0" y="0"/>
                </a:lnTo>
                <a:lnTo>
                  <a:pt x="0" y="3675"/>
                </a:lnTo>
                <a:lnTo>
                  <a:pt x="56772" y="3675"/>
                </a:lnTo>
                <a:lnTo>
                  <a:pt x="56772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bg object 38"/>
          <p:cNvSpPr/>
          <p:nvPr/>
        </p:nvSpPr>
        <p:spPr>
          <a:xfrm>
            <a:off x="2124663" y="1747739"/>
            <a:ext cx="57150" cy="1905"/>
          </a:xfrm>
          <a:custGeom>
            <a:avLst/>
            <a:gdLst/>
            <a:ahLst/>
            <a:cxnLst/>
            <a:rect l="l" t="t" r="r" b="b"/>
            <a:pathLst>
              <a:path w="57150" h="1905">
                <a:moveTo>
                  <a:pt x="56669" y="0"/>
                </a:moveTo>
                <a:lnTo>
                  <a:pt x="0" y="0"/>
                </a:lnTo>
                <a:lnTo>
                  <a:pt x="0" y="1735"/>
                </a:lnTo>
                <a:lnTo>
                  <a:pt x="56669" y="1735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bg object 39"/>
          <p:cNvSpPr/>
          <p:nvPr/>
        </p:nvSpPr>
        <p:spPr>
          <a:xfrm>
            <a:off x="2219317" y="1549854"/>
            <a:ext cx="57150" cy="200025"/>
          </a:xfrm>
          <a:custGeom>
            <a:avLst/>
            <a:gdLst/>
            <a:ahLst/>
            <a:cxnLst/>
            <a:rect l="l" t="t" r="r" b="b"/>
            <a:pathLst>
              <a:path w="57150" h="200025">
                <a:moveTo>
                  <a:pt x="56669" y="0"/>
                </a:moveTo>
                <a:lnTo>
                  <a:pt x="0" y="0"/>
                </a:lnTo>
                <a:lnTo>
                  <a:pt x="0" y="199621"/>
                </a:lnTo>
                <a:lnTo>
                  <a:pt x="56669" y="199621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bg object 40"/>
          <p:cNvSpPr/>
          <p:nvPr/>
        </p:nvSpPr>
        <p:spPr>
          <a:xfrm>
            <a:off x="2275987" y="1560882"/>
            <a:ext cx="57150" cy="188595"/>
          </a:xfrm>
          <a:custGeom>
            <a:avLst/>
            <a:gdLst/>
            <a:ahLst/>
            <a:cxnLst/>
            <a:rect l="l" t="t" r="r" b="b"/>
            <a:pathLst>
              <a:path w="57150" h="188594">
                <a:moveTo>
                  <a:pt x="56772" y="0"/>
                </a:moveTo>
                <a:lnTo>
                  <a:pt x="0" y="0"/>
                </a:lnTo>
                <a:lnTo>
                  <a:pt x="0" y="188593"/>
                </a:lnTo>
                <a:lnTo>
                  <a:pt x="56772" y="188593"/>
                </a:lnTo>
                <a:lnTo>
                  <a:pt x="56772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bg object 41"/>
          <p:cNvSpPr/>
          <p:nvPr/>
        </p:nvSpPr>
        <p:spPr>
          <a:xfrm>
            <a:off x="2370743" y="1731504"/>
            <a:ext cx="57150" cy="18415"/>
          </a:xfrm>
          <a:custGeom>
            <a:avLst/>
            <a:gdLst/>
            <a:ahLst/>
            <a:cxnLst/>
            <a:rect l="l" t="t" r="r" b="b"/>
            <a:pathLst>
              <a:path w="57150" h="18414">
                <a:moveTo>
                  <a:pt x="56669" y="0"/>
                </a:moveTo>
                <a:lnTo>
                  <a:pt x="0" y="0"/>
                </a:lnTo>
                <a:lnTo>
                  <a:pt x="0" y="17971"/>
                </a:lnTo>
                <a:lnTo>
                  <a:pt x="56669" y="17971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bg object 42"/>
          <p:cNvSpPr/>
          <p:nvPr/>
        </p:nvSpPr>
        <p:spPr>
          <a:xfrm>
            <a:off x="2427413" y="1720987"/>
            <a:ext cx="57150" cy="28575"/>
          </a:xfrm>
          <a:custGeom>
            <a:avLst/>
            <a:gdLst/>
            <a:ahLst/>
            <a:cxnLst/>
            <a:rect l="l" t="t" r="r" b="b"/>
            <a:pathLst>
              <a:path w="57150" h="28575">
                <a:moveTo>
                  <a:pt x="56669" y="0"/>
                </a:moveTo>
                <a:lnTo>
                  <a:pt x="0" y="0"/>
                </a:lnTo>
                <a:lnTo>
                  <a:pt x="0" y="28488"/>
                </a:lnTo>
                <a:lnTo>
                  <a:pt x="56669" y="28488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bg object 43"/>
          <p:cNvSpPr/>
          <p:nvPr/>
        </p:nvSpPr>
        <p:spPr>
          <a:xfrm>
            <a:off x="2522067" y="1747944"/>
            <a:ext cx="57150" cy="1905"/>
          </a:xfrm>
          <a:custGeom>
            <a:avLst/>
            <a:gdLst/>
            <a:ahLst/>
            <a:cxnLst/>
            <a:rect l="l" t="t" r="r" b="b"/>
            <a:pathLst>
              <a:path w="57150" h="1905">
                <a:moveTo>
                  <a:pt x="56772" y="0"/>
                </a:moveTo>
                <a:lnTo>
                  <a:pt x="0" y="0"/>
                </a:lnTo>
                <a:lnTo>
                  <a:pt x="0" y="1531"/>
                </a:lnTo>
                <a:lnTo>
                  <a:pt x="56772" y="1531"/>
                </a:lnTo>
                <a:lnTo>
                  <a:pt x="56772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bg object 44"/>
          <p:cNvSpPr/>
          <p:nvPr/>
        </p:nvSpPr>
        <p:spPr>
          <a:xfrm>
            <a:off x="2578839" y="1748250"/>
            <a:ext cx="57150" cy="1270"/>
          </a:xfrm>
          <a:custGeom>
            <a:avLst/>
            <a:gdLst/>
            <a:ahLst/>
            <a:cxnLst/>
            <a:rect l="l" t="t" r="r" b="b"/>
            <a:pathLst>
              <a:path w="57150" h="1269">
                <a:moveTo>
                  <a:pt x="56669" y="0"/>
                </a:moveTo>
                <a:lnTo>
                  <a:pt x="0" y="0"/>
                </a:lnTo>
                <a:lnTo>
                  <a:pt x="0" y="1225"/>
                </a:lnTo>
                <a:lnTo>
                  <a:pt x="56669" y="1225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bg object 45"/>
          <p:cNvSpPr/>
          <p:nvPr/>
        </p:nvSpPr>
        <p:spPr>
          <a:xfrm>
            <a:off x="2673493" y="1721191"/>
            <a:ext cx="57150" cy="28575"/>
          </a:xfrm>
          <a:custGeom>
            <a:avLst/>
            <a:gdLst/>
            <a:ahLst/>
            <a:cxnLst/>
            <a:rect l="l" t="t" r="r" b="b"/>
            <a:pathLst>
              <a:path w="57150" h="28575">
                <a:moveTo>
                  <a:pt x="56669" y="0"/>
                </a:moveTo>
                <a:lnTo>
                  <a:pt x="0" y="0"/>
                </a:lnTo>
                <a:lnTo>
                  <a:pt x="0" y="28283"/>
                </a:lnTo>
                <a:lnTo>
                  <a:pt x="56669" y="28283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bg object 46"/>
          <p:cNvSpPr/>
          <p:nvPr/>
        </p:nvSpPr>
        <p:spPr>
          <a:xfrm>
            <a:off x="2730163" y="1727828"/>
            <a:ext cx="57150" cy="22225"/>
          </a:xfrm>
          <a:custGeom>
            <a:avLst/>
            <a:gdLst/>
            <a:ahLst/>
            <a:cxnLst/>
            <a:rect l="l" t="t" r="r" b="b"/>
            <a:pathLst>
              <a:path w="57150" h="22225">
                <a:moveTo>
                  <a:pt x="56772" y="0"/>
                </a:moveTo>
                <a:lnTo>
                  <a:pt x="0" y="0"/>
                </a:lnTo>
                <a:lnTo>
                  <a:pt x="0" y="21646"/>
                </a:lnTo>
                <a:lnTo>
                  <a:pt x="56772" y="21646"/>
                </a:lnTo>
                <a:lnTo>
                  <a:pt x="56772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bg object 47"/>
          <p:cNvSpPr/>
          <p:nvPr/>
        </p:nvSpPr>
        <p:spPr>
          <a:xfrm>
            <a:off x="2824919" y="1650226"/>
            <a:ext cx="57150" cy="99695"/>
          </a:xfrm>
          <a:custGeom>
            <a:avLst/>
            <a:gdLst/>
            <a:ahLst/>
            <a:cxnLst/>
            <a:rect l="l" t="t" r="r" b="b"/>
            <a:pathLst>
              <a:path w="57150" h="99694">
                <a:moveTo>
                  <a:pt x="56669" y="0"/>
                </a:moveTo>
                <a:lnTo>
                  <a:pt x="0" y="0"/>
                </a:lnTo>
                <a:lnTo>
                  <a:pt x="0" y="99248"/>
                </a:lnTo>
                <a:lnTo>
                  <a:pt x="56669" y="99248"/>
                </a:lnTo>
                <a:lnTo>
                  <a:pt x="56669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bg object 48"/>
          <p:cNvSpPr/>
          <p:nvPr/>
        </p:nvSpPr>
        <p:spPr>
          <a:xfrm>
            <a:off x="2881589" y="1634604"/>
            <a:ext cx="57150" cy="114935"/>
          </a:xfrm>
          <a:custGeom>
            <a:avLst/>
            <a:gdLst/>
            <a:ahLst/>
            <a:cxnLst/>
            <a:rect l="l" t="t" r="r" b="b"/>
            <a:pathLst>
              <a:path w="57150" h="114935">
                <a:moveTo>
                  <a:pt x="56669" y="0"/>
                </a:moveTo>
                <a:lnTo>
                  <a:pt x="0" y="0"/>
                </a:lnTo>
                <a:lnTo>
                  <a:pt x="0" y="114871"/>
                </a:lnTo>
                <a:lnTo>
                  <a:pt x="56669" y="114871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bg object 49"/>
          <p:cNvSpPr/>
          <p:nvPr/>
        </p:nvSpPr>
        <p:spPr>
          <a:xfrm>
            <a:off x="2976243" y="1740898"/>
            <a:ext cx="57150" cy="8890"/>
          </a:xfrm>
          <a:custGeom>
            <a:avLst/>
            <a:gdLst/>
            <a:ahLst/>
            <a:cxnLst/>
            <a:rect l="l" t="t" r="r" b="b"/>
            <a:pathLst>
              <a:path w="57150" h="8889">
                <a:moveTo>
                  <a:pt x="56772" y="0"/>
                </a:moveTo>
                <a:lnTo>
                  <a:pt x="0" y="0"/>
                </a:lnTo>
                <a:lnTo>
                  <a:pt x="0" y="8577"/>
                </a:lnTo>
                <a:lnTo>
                  <a:pt x="56772" y="8577"/>
                </a:lnTo>
                <a:lnTo>
                  <a:pt x="56772" y="0"/>
                </a:lnTo>
                <a:close/>
              </a:path>
            </a:pathLst>
          </a:custGeom>
          <a:solidFill>
            <a:srgbClr val="5F5F5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bg object 50"/>
          <p:cNvSpPr/>
          <p:nvPr/>
        </p:nvSpPr>
        <p:spPr>
          <a:xfrm>
            <a:off x="3033015" y="1739469"/>
            <a:ext cx="57150" cy="10160"/>
          </a:xfrm>
          <a:custGeom>
            <a:avLst/>
            <a:gdLst/>
            <a:ahLst/>
            <a:cxnLst/>
            <a:rect l="l" t="t" r="r" b="b"/>
            <a:pathLst>
              <a:path w="57150" h="10160">
                <a:moveTo>
                  <a:pt x="56669" y="0"/>
                </a:moveTo>
                <a:lnTo>
                  <a:pt x="0" y="0"/>
                </a:lnTo>
                <a:lnTo>
                  <a:pt x="0" y="10006"/>
                </a:lnTo>
                <a:lnTo>
                  <a:pt x="56669" y="10006"/>
                </a:lnTo>
                <a:lnTo>
                  <a:pt x="56669" y="0"/>
                </a:lnTo>
                <a:close/>
              </a:path>
            </a:pathLst>
          </a:custGeom>
          <a:solidFill>
            <a:srgbClr val="9F9F9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bg object 51"/>
          <p:cNvSpPr/>
          <p:nvPr/>
        </p:nvSpPr>
        <p:spPr>
          <a:xfrm>
            <a:off x="275078" y="84400"/>
            <a:ext cx="33020" cy="1665605"/>
          </a:xfrm>
          <a:custGeom>
            <a:avLst/>
            <a:gdLst/>
            <a:ahLst/>
            <a:cxnLst/>
            <a:rect l="l" t="t" r="r" b="b"/>
            <a:pathLst>
              <a:path w="33020" h="1665605">
                <a:moveTo>
                  <a:pt x="32980" y="1665075"/>
                </a:moveTo>
                <a:lnTo>
                  <a:pt x="32980" y="0"/>
                </a:lnTo>
              </a:path>
              <a:path w="33020" h="1665605">
                <a:moveTo>
                  <a:pt x="32980" y="1665075"/>
                </a:moveTo>
                <a:lnTo>
                  <a:pt x="0" y="1665075"/>
                </a:lnTo>
              </a:path>
              <a:path w="33020" h="1665605">
                <a:moveTo>
                  <a:pt x="32980" y="1439007"/>
                </a:moveTo>
                <a:lnTo>
                  <a:pt x="0" y="1439007"/>
                </a:lnTo>
              </a:path>
              <a:path w="33020" h="1665605">
                <a:moveTo>
                  <a:pt x="32980" y="1213043"/>
                </a:moveTo>
                <a:lnTo>
                  <a:pt x="0" y="1213043"/>
                </a:lnTo>
              </a:path>
              <a:path w="33020" h="1665605">
                <a:moveTo>
                  <a:pt x="32980" y="987078"/>
                </a:moveTo>
                <a:lnTo>
                  <a:pt x="0" y="987078"/>
                </a:lnTo>
              </a:path>
              <a:path w="33020" h="1665605">
                <a:moveTo>
                  <a:pt x="32980" y="761113"/>
                </a:moveTo>
                <a:lnTo>
                  <a:pt x="0" y="761113"/>
                </a:lnTo>
              </a:path>
              <a:path w="33020" h="1665605">
                <a:moveTo>
                  <a:pt x="32980" y="535148"/>
                </a:moveTo>
                <a:lnTo>
                  <a:pt x="0" y="535148"/>
                </a:lnTo>
              </a:path>
              <a:path w="33020" h="1665605">
                <a:moveTo>
                  <a:pt x="32980" y="309080"/>
                </a:moveTo>
                <a:lnTo>
                  <a:pt x="0" y="309080"/>
                </a:lnTo>
              </a:path>
              <a:path w="33020" h="1665605">
                <a:moveTo>
                  <a:pt x="32980" y="83115"/>
                </a:moveTo>
                <a:lnTo>
                  <a:pt x="0" y="83115"/>
                </a:lnTo>
              </a:path>
            </a:pathLst>
          </a:custGeom>
          <a:ln w="475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163512" y="95250"/>
            <a:ext cx="2943225" cy="381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163512" y="547687"/>
            <a:ext cx="2943225" cy="15716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1111885" y="2214562"/>
            <a:ext cx="1046480" cy="11906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163512" y="2214562"/>
            <a:ext cx="752157" cy="11906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27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2354580" y="2214562"/>
            <a:ext cx="752157" cy="11906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79186" y="111931"/>
            <a:ext cx="92710" cy="1686560"/>
          </a:xfrm>
          <a:prstGeom prst="rect">
            <a:avLst/>
          </a:prstGeom>
        </p:spPr>
        <p:txBody>
          <a:bodyPr vert="horz" wrap="square" lIns="0" tIns="1524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sz="500" dirty="0">
                <a:latin typeface="Calibri"/>
                <a:cs typeface="Calibri"/>
              </a:rPr>
              <a:t>7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45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500" dirty="0">
                <a:latin typeface="Calibri"/>
                <a:cs typeface="Calibri"/>
              </a:rPr>
              <a:t>6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45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500" dirty="0">
                <a:latin typeface="Calibri"/>
                <a:cs typeface="Calibri"/>
              </a:rPr>
              <a:t>5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45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500" dirty="0">
                <a:latin typeface="Calibri"/>
                <a:cs typeface="Calibri"/>
              </a:rPr>
              <a:t>4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45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500" dirty="0">
                <a:latin typeface="Calibri"/>
                <a:cs typeface="Calibri"/>
              </a:rPr>
              <a:t>3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45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500" dirty="0">
                <a:latin typeface="Calibri"/>
                <a:cs typeface="Calibri"/>
              </a:rPr>
              <a:t>2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450" dirty="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</a:pPr>
            <a:r>
              <a:rPr sz="500" dirty="0">
                <a:latin typeface="Calibri"/>
                <a:cs typeface="Calibri"/>
              </a:rPr>
              <a:t>10</a:t>
            </a:r>
          </a:p>
          <a:p>
            <a:pPr>
              <a:lnSpc>
                <a:spcPct val="100000"/>
              </a:lnSpc>
            </a:pPr>
            <a:endParaRPr sz="500" dirty="0">
              <a:latin typeface="Calibri"/>
              <a:cs typeface="Calibri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450" dirty="0">
              <a:latin typeface="Calibri"/>
              <a:cs typeface="Calibri"/>
            </a:endParaRPr>
          </a:p>
          <a:p>
            <a:pPr marL="45720">
              <a:lnSpc>
                <a:spcPct val="100000"/>
              </a:lnSpc>
            </a:pPr>
            <a:r>
              <a:rPr sz="500" spc="5" dirty="0">
                <a:latin typeface="Calibri"/>
                <a:cs typeface="Calibri"/>
              </a:rPr>
              <a:t>0</a:t>
            </a:r>
            <a:endParaRPr sz="500" dirty="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83638" y="588385"/>
            <a:ext cx="91440" cy="65849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590"/>
              </a:lnSpc>
            </a:pPr>
            <a:r>
              <a:rPr sz="500" dirty="0">
                <a:latin typeface="Calibri"/>
                <a:cs typeface="Calibri"/>
              </a:rPr>
              <a:t>Energy</a:t>
            </a:r>
            <a:r>
              <a:rPr sz="500" spc="-5" dirty="0">
                <a:latin typeface="Calibri"/>
                <a:cs typeface="Calibri"/>
              </a:rPr>
              <a:t> </a:t>
            </a:r>
            <a:r>
              <a:rPr sz="500" dirty="0">
                <a:latin typeface="Calibri"/>
                <a:cs typeface="Calibri"/>
              </a:rPr>
              <a:t>contribution</a:t>
            </a:r>
            <a:r>
              <a:rPr sz="500" spc="-5" dirty="0">
                <a:latin typeface="Calibri"/>
                <a:cs typeface="Calibri"/>
              </a:rPr>
              <a:t> </a:t>
            </a:r>
            <a:r>
              <a:rPr sz="500" dirty="0">
                <a:latin typeface="Calibri"/>
                <a:cs typeface="Calibri"/>
              </a:rPr>
              <a:t>(%)</a:t>
            </a:r>
            <a:endParaRPr sz="500">
              <a:latin typeface="Calibri"/>
              <a:cs typeface="Calibri"/>
            </a:endParaRPr>
          </a:p>
        </p:txBody>
      </p:sp>
      <p:sp>
        <p:nvSpPr>
          <p:cNvPr id="4" name="object 4"/>
          <p:cNvSpPr/>
          <p:nvPr/>
        </p:nvSpPr>
        <p:spPr>
          <a:xfrm>
            <a:off x="308059" y="1749475"/>
            <a:ext cx="2876550" cy="0"/>
          </a:xfrm>
          <a:custGeom>
            <a:avLst/>
            <a:gdLst/>
            <a:ahLst/>
            <a:cxnLst/>
            <a:rect l="l" t="t" r="r" b="b"/>
            <a:pathLst>
              <a:path w="2876550">
                <a:moveTo>
                  <a:pt x="0" y="0"/>
                </a:moveTo>
                <a:lnTo>
                  <a:pt x="2876075" y="0"/>
                </a:lnTo>
              </a:path>
            </a:pathLst>
          </a:custGeom>
          <a:ln w="4752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 txBox="1"/>
          <p:nvPr/>
        </p:nvSpPr>
        <p:spPr>
          <a:xfrm rot="18900000">
            <a:off x="-77309" y="1986866"/>
            <a:ext cx="633130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Grains,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roots,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tubers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plantain</a:t>
            </a:r>
            <a:endParaRPr sz="350" dirty="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 rot="18900000">
            <a:off x="145052" y="1957137"/>
            <a:ext cx="550238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Pulses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(beans,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peas,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5" dirty="0">
                <a:latin typeface="Calibri"/>
                <a:cs typeface="Calibri"/>
              </a:rPr>
              <a:t>lentils)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 rot="18900000">
            <a:off x="538039" y="1856438"/>
            <a:ext cx="268763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Nuts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15" dirty="0">
                <a:latin typeface="Calibri"/>
                <a:cs typeface="Calibri"/>
              </a:rPr>
              <a:t>seed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 rot="18900000">
            <a:off x="821683" y="1800255"/>
            <a:ext cx="116466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Dairy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 rot="18900000">
            <a:off x="721878" y="1906163"/>
            <a:ext cx="406885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Meat,</a:t>
            </a:r>
            <a:r>
              <a:rPr sz="350" spc="-1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poultry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-10" dirty="0">
                <a:latin typeface="Calibri"/>
                <a:cs typeface="Calibri"/>
              </a:rPr>
              <a:t> </a:t>
            </a:r>
            <a:r>
              <a:rPr sz="350" spc="5" dirty="0">
                <a:latin typeface="Calibri"/>
                <a:cs typeface="Calibri"/>
              </a:rPr>
              <a:t>fish</a:t>
            </a:r>
            <a:endParaRPr sz="350" dirty="0">
              <a:latin typeface="Calibri"/>
              <a:cs typeface="Calibri"/>
            </a:endParaRPr>
          </a:p>
        </p:txBody>
      </p:sp>
      <p:sp>
        <p:nvSpPr>
          <p:cNvPr id="10" name="object 10"/>
          <p:cNvSpPr txBox="1"/>
          <p:nvPr/>
        </p:nvSpPr>
        <p:spPr>
          <a:xfrm rot="18900000">
            <a:off x="1136561" y="1794935"/>
            <a:ext cx="102877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Egg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 rot="18900000">
            <a:off x="894859" y="1960111"/>
            <a:ext cx="559093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Dark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green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leafy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vegetables</a:t>
            </a:r>
            <a:endParaRPr sz="350" dirty="0">
              <a:latin typeface="Calibri"/>
              <a:cs typeface="Calibri"/>
            </a:endParaRPr>
          </a:p>
        </p:txBody>
      </p:sp>
      <p:sp>
        <p:nvSpPr>
          <p:cNvPr id="12" name="object 12"/>
          <p:cNvSpPr txBox="1"/>
          <p:nvPr/>
        </p:nvSpPr>
        <p:spPr>
          <a:xfrm rot="18900000">
            <a:off x="971236" y="1988405"/>
            <a:ext cx="646879" cy="51296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Vitamin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A-rich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fruits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lang="nl-NL" sz="350" spc="-5" dirty="0" smtClean="0">
                <a:latin typeface="Calibri"/>
                <a:cs typeface="Calibri"/>
              </a:rPr>
              <a:t>vegetables</a:t>
            </a:r>
            <a:endParaRPr sz="350" dirty="0">
              <a:latin typeface="Calibri"/>
              <a:cs typeface="Calibri"/>
            </a:endParaRPr>
          </a:p>
        </p:txBody>
      </p:sp>
      <p:sp>
        <p:nvSpPr>
          <p:cNvPr id="13" name="object 13"/>
          <p:cNvSpPr txBox="1"/>
          <p:nvPr/>
        </p:nvSpPr>
        <p:spPr>
          <a:xfrm rot="18900000">
            <a:off x="1377932" y="1884995"/>
            <a:ext cx="348344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Othe</a:t>
            </a:r>
            <a:r>
              <a:rPr sz="350" spc="10" dirty="0">
                <a:latin typeface="Calibri"/>
                <a:cs typeface="Calibri"/>
              </a:rPr>
              <a:t>r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vegetables</a:t>
            </a:r>
            <a:endParaRPr sz="350" dirty="0">
              <a:latin typeface="Calibri"/>
              <a:cs typeface="Calibri"/>
            </a:endParaRPr>
          </a:p>
        </p:txBody>
      </p:sp>
      <p:sp>
        <p:nvSpPr>
          <p:cNvPr id="14" name="object 14"/>
          <p:cNvSpPr txBox="1"/>
          <p:nvPr/>
        </p:nvSpPr>
        <p:spPr>
          <a:xfrm rot="18900000">
            <a:off x="1623013" y="1845752"/>
            <a:ext cx="239492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Othe</a:t>
            </a:r>
            <a:r>
              <a:rPr sz="350" spc="10" dirty="0">
                <a:latin typeface="Calibri"/>
                <a:cs typeface="Calibri"/>
              </a:rPr>
              <a:t>r</a:t>
            </a:r>
            <a:r>
              <a:rPr sz="350" spc="5" dirty="0">
                <a:latin typeface="Calibri"/>
                <a:cs typeface="Calibri"/>
              </a:rPr>
              <a:t> fruits</a:t>
            </a:r>
            <a:endParaRPr sz="350" dirty="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 rot="18900000">
            <a:off x="1853674" y="1812363"/>
            <a:ext cx="148220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Insect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 rot="18900000">
            <a:off x="1913061" y="1851290"/>
            <a:ext cx="254422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Re</a:t>
            </a:r>
            <a:r>
              <a:rPr sz="350" spc="20" dirty="0">
                <a:latin typeface="Calibri"/>
                <a:cs typeface="Calibri"/>
              </a:rPr>
              <a:t>d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pal</a:t>
            </a:r>
            <a:r>
              <a:rPr sz="350" spc="30" dirty="0">
                <a:latin typeface="Calibri"/>
                <a:cs typeface="Calibri"/>
              </a:rPr>
              <a:t>m</a:t>
            </a:r>
            <a:r>
              <a:rPr sz="350" spc="5" dirty="0">
                <a:latin typeface="Calibri"/>
                <a:cs typeface="Calibri"/>
              </a:rPr>
              <a:t> oil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 rot="18900000">
            <a:off x="1998172" y="1878837"/>
            <a:ext cx="331382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Other</a:t>
            </a:r>
            <a:r>
              <a:rPr sz="350" spc="-1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oils</a:t>
            </a:r>
            <a:r>
              <a:rPr sz="350" spc="-10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fat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 rot="18900000">
            <a:off x="2042088" y="1923631"/>
            <a:ext cx="456718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Savoury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fried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15" dirty="0">
                <a:latin typeface="Calibri"/>
                <a:cs typeface="Calibri"/>
              </a:rPr>
              <a:t>snack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 rot="18900000">
            <a:off x="2455935" y="1813722"/>
            <a:ext cx="151816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Sweet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 rot="18900000">
            <a:off x="2248847" y="1963595"/>
            <a:ext cx="569214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Sugar-sweetened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beverage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21" name="object 21"/>
          <p:cNvSpPr txBox="1"/>
          <p:nvPr/>
        </p:nvSpPr>
        <p:spPr>
          <a:xfrm rot="18900000">
            <a:off x="2442461" y="1945897"/>
            <a:ext cx="519889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5" dirty="0">
                <a:latin typeface="Calibri"/>
                <a:cs typeface="Calibri"/>
              </a:rPr>
              <a:t>Condiments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spc="5" dirty="0">
                <a:latin typeface="Calibri"/>
                <a:cs typeface="Calibri"/>
              </a:rPr>
              <a:t> </a:t>
            </a:r>
            <a:r>
              <a:rPr sz="350" spc="15" dirty="0">
                <a:latin typeface="Calibri"/>
                <a:cs typeface="Calibri"/>
              </a:rPr>
              <a:t>seasonings</a:t>
            </a:r>
            <a:endParaRPr sz="350">
              <a:latin typeface="Calibri"/>
              <a:cs typeface="Calibri"/>
            </a:endParaRPr>
          </a:p>
        </p:txBody>
      </p:sp>
      <p:sp>
        <p:nvSpPr>
          <p:cNvPr id="22" name="object 22"/>
          <p:cNvSpPr txBox="1"/>
          <p:nvPr/>
        </p:nvSpPr>
        <p:spPr>
          <a:xfrm rot="18900000">
            <a:off x="2606010" y="1940933"/>
            <a:ext cx="505353" cy="457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ts val="360"/>
              </a:lnSpc>
            </a:pPr>
            <a:r>
              <a:rPr sz="350" spc="10" dirty="0">
                <a:latin typeface="Calibri"/>
                <a:cs typeface="Calibri"/>
              </a:rPr>
              <a:t>Other</a:t>
            </a:r>
            <a:r>
              <a:rPr sz="350" spc="-5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beverages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25" dirty="0">
                <a:latin typeface="Calibri"/>
                <a:cs typeface="Calibri"/>
              </a:rPr>
              <a:t>&amp;</a:t>
            </a:r>
            <a:r>
              <a:rPr sz="350" dirty="0">
                <a:latin typeface="Calibri"/>
                <a:cs typeface="Calibri"/>
              </a:rPr>
              <a:t> </a:t>
            </a:r>
            <a:r>
              <a:rPr sz="350" spc="10" dirty="0">
                <a:latin typeface="Calibri"/>
                <a:cs typeface="Calibri"/>
              </a:rPr>
              <a:t>foods</a:t>
            </a:r>
            <a:endParaRPr sz="350">
              <a:latin typeface="Calibri"/>
              <a:cs typeface="Calibri"/>
            </a:endParaRPr>
          </a:p>
        </p:txBody>
      </p:sp>
      <p:grpSp>
        <p:nvGrpSpPr>
          <p:cNvPr id="28" name="Groep 27"/>
          <p:cNvGrpSpPr/>
          <p:nvPr/>
        </p:nvGrpSpPr>
        <p:grpSpPr>
          <a:xfrm>
            <a:off x="2317748" y="108080"/>
            <a:ext cx="1034913" cy="146194"/>
            <a:chOff x="1742758" y="84549"/>
            <a:chExt cx="986556" cy="146194"/>
          </a:xfrm>
        </p:grpSpPr>
        <p:sp>
          <p:nvSpPr>
            <p:cNvPr id="23" name="Rechthoek 22"/>
            <p:cNvSpPr/>
            <p:nvPr/>
          </p:nvSpPr>
          <p:spPr>
            <a:xfrm flipV="1">
              <a:off x="1765126" y="134789"/>
              <a:ext cx="169029" cy="45719"/>
            </a:xfrm>
            <a:prstGeom prst="rect">
              <a:avLst/>
            </a:prstGeom>
            <a:solidFill>
              <a:srgbClr val="5F5F5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Rechthoek 23"/>
            <p:cNvSpPr/>
            <p:nvPr/>
          </p:nvSpPr>
          <p:spPr>
            <a:xfrm flipV="1">
              <a:off x="2138245" y="134787"/>
              <a:ext cx="169029" cy="45719"/>
            </a:xfrm>
            <a:prstGeom prst="rect">
              <a:avLst/>
            </a:prstGeom>
            <a:solidFill>
              <a:srgbClr val="9F9F9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Tekstvak 24"/>
            <p:cNvSpPr txBox="1"/>
            <p:nvPr/>
          </p:nvSpPr>
          <p:spPr>
            <a:xfrm>
              <a:off x="1946848" y="131999"/>
              <a:ext cx="311551" cy="51296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>
              <a:defPPr>
                <a:defRPr lang="nl-NL"/>
              </a:defPPr>
              <a:lvl1pPr>
                <a:lnSpc>
                  <a:spcPts val="360"/>
                </a:lnSpc>
                <a:defRPr sz="350" spc="15">
                  <a:latin typeface="Calibri"/>
                  <a:cs typeface="Calibri"/>
                </a:defRPr>
              </a:lvl1pPr>
            </a:lstStyle>
            <a:p>
              <a:r>
                <a:rPr lang="en-GB" dirty="0"/>
                <a:t>Control</a:t>
              </a:r>
              <a:endParaRPr lang="en-GB" dirty="0"/>
            </a:p>
          </p:txBody>
        </p:sp>
        <p:sp>
          <p:nvSpPr>
            <p:cNvPr id="26" name="Tekstvak 25"/>
            <p:cNvSpPr txBox="1"/>
            <p:nvPr/>
          </p:nvSpPr>
          <p:spPr>
            <a:xfrm>
              <a:off x="2235425" y="84549"/>
              <a:ext cx="493889" cy="146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350" spc="10" dirty="0">
                  <a:latin typeface="Calibri"/>
                  <a:cs typeface="Calibri"/>
                </a:rPr>
                <a:t>Intervention</a:t>
              </a:r>
            </a:p>
          </p:txBody>
        </p:sp>
        <p:sp>
          <p:nvSpPr>
            <p:cNvPr id="27" name="Rechthoek 26"/>
            <p:cNvSpPr/>
            <p:nvPr/>
          </p:nvSpPr>
          <p:spPr>
            <a:xfrm>
              <a:off x="1742758" y="111931"/>
              <a:ext cx="826354" cy="92108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61F55EFCD26EB44BD2B8309486F9A4C" ma:contentTypeVersion="14" ma:contentTypeDescription="Een nieuw document maken." ma:contentTypeScope="" ma:versionID="9c59bf0221d6675249f48a7f3d205193">
  <xsd:schema xmlns:xsd="http://www.w3.org/2001/XMLSchema" xmlns:xs="http://www.w3.org/2001/XMLSchema" xmlns:p="http://schemas.microsoft.com/office/2006/metadata/properties" xmlns:ns3="69a0d7c4-424f-4218-a648-25e65a7b6d62" xmlns:ns4="db862df7-5582-41ac-b534-ebdc2a671e89" targetNamespace="http://schemas.microsoft.com/office/2006/metadata/properties" ma:root="true" ma:fieldsID="d52284be4f60589d8ddb502a3200635f" ns3:_="" ns4:_="">
    <xsd:import namespace="69a0d7c4-424f-4218-a648-25e65a7b6d62"/>
    <xsd:import namespace="db862df7-5582-41ac-b534-ebdc2a671e8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9a0d7c4-424f-4218-a648-25e65a7b6d6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5" nillable="true" ma:displayName="MediaService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b862df7-5582-41ac-b534-ebdc2a671e89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Gedeeld met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Gedeeld met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int-hash delen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39DD976-0ABA-4F7E-99AC-A3CCA455596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A0AD51B-2726-4EE6-8313-11E28F2F74A7}">
  <ds:schemaRefs>
    <ds:schemaRef ds:uri="db862df7-5582-41ac-b534-ebdc2a671e89"/>
    <ds:schemaRef ds:uri="http://purl.org/dc/elements/1.1/"/>
    <ds:schemaRef ds:uri="http://schemas.microsoft.com/office/2006/metadata/properties"/>
    <ds:schemaRef ds:uri="69a0d7c4-424f-4218-a648-25e65a7b6d62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CD9DB991-61DB-4741-B413-FE311123AF2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9a0d7c4-424f-4218-a648-25e65a7b6d62"/>
    <ds:schemaRef ds:uri="db862df7-5582-41ac-b534-ebdc2a671e8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Words>73</Words>
  <Application>Microsoft Office PowerPoint</Application>
  <PresentationFormat>Aangepast</PresentationFormat>
  <Paragraphs>43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1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Calibri</vt:lpstr>
      <vt:lpstr>Office Them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renda de Kok</dc:creator>
  <cp:lastModifiedBy>Brenda de Kok</cp:lastModifiedBy>
  <cp:revision>3</cp:revision>
  <dcterms:created xsi:type="dcterms:W3CDTF">2021-06-07T15:46:52Z</dcterms:created>
  <dcterms:modified xsi:type="dcterms:W3CDTF">2021-07-27T08:3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61F55EFCD26EB44BD2B8309486F9A4C</vt:lpwstr>
  </property>
</Properties>
</file>